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0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51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8E7DC-6398-4905-A8C5-4AC6749FDA52}" type="datetimeFigureOut">
              <a:rPr lang="en-US" smtClean="0"/>
              <a:t>5/1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53BCF-FB57-4E16-8B63-C4B4E9EED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23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8E7DC-6398-4905-A8C5-4AC6749FDA52}" type="datetimeFigureOut">
              <a:rPr lang="en-US" smtClean="0"/>
              <a:t>5/1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53BCF-FB57-4E16-8B63-C4B4E9EED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158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8E7DC-6398-4905-A8C5-4AC6749FDA52}" type="datetimeFigureOut">
              <a:rPr lang="en-US" smtClean="0"/>
              <a:t>5/1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53BCF-FB57-4E16-8B63-C4B4E9EED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01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8E7DC-6398-4905-A8C5-4AC6749FDA52}" type="datetimeFigureOut">
              <a:rPr lang="en-US" smtClean="0"/>
              <a:t>5/1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53BCF-FB57-4E16-8B63-C4B4E9EED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763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8E7DC-6398-4905-A8C5-4AC6749FDA52}" type="datetimeFigureOut">
              <a:rPr lang="en-US" smtClean="0"/>
              <a:t>5/1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53BCF-FB57-4E16-8B63-C4B4E9EED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6017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8E7DC-6398-4905-A8C5-4AC6749FDA52}" type="datetimeFigureOut">
              <a:rPr lang="en-US" smtClean="0"/>
              <a:t>5/14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53BCF-FB57-4E16-8B63-C4B4E9EED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8009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8E7DC-6398-4905-A8C5-4AC6749FDA52}" type="datetimeFigureOut">
              <a:rPr lang="en-US" smtClean="0"/>
              <a:t>5/14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53BCF-FB57-4E16-8B63-C4B4E9EED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16540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8E7DC-6398-4905-A8C5-4AC6749FDA52}" type="datetimeFigureOut">
              <a:rPr lang="en-US" smtClean="0"/>
              <a:t>5/14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53BCF-FB57-4E16-8B63-C4B4E9EED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876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8E7DC-6398-4905-A8C5-4AC6749FDA52}" type="datetimeFigureOut">
              <a:rPr lang="en-US" smtClean="0"/>
              <a:t>5/14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53BCF-FB57-4E16-8B63-C4B4E9EED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8817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8E7DC-6398-4905-A8C5-4AC6749FDA52}" type="datetimeFigureOut">
              <a:rPr lang="en-US" smtClean="0"/>
              <a:t>5/14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53BCF-FB57-4E16-8B63-C4B4E9EED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4293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8E7DC-6398-4905-A8C5-4AC6749FDA52}" type="datetimeFigureOut">
              <a:rPr lang="en-US" smtClean="0"/>
              <a:t>5/14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53BCF-FB57-4E16-8B63-C4B4E9EED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5276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98E7DC-6398-4905-A8C5-4AC6749FDA52}" type="datetimeFigureOut">
              <a:rPr lang="en-US" smtClean="0"/>
              <a:t>5/1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653BCF-FB57-4E16-8B63-C4B4E9EED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755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l"/>
            <a:r>
              <a:rPr lang="en-US" sz="2000" dirty="0" smtClean="0"/>
              <a:t>A) Markers </a:t>
            </a:r>
            <a:r>
              <a:rPr lang="en-US" sz="2000" dirty="0"/>
              <a:t>on the body </a:t>
            </a:r>
            <a:r>
              <a:rPr lang="en-US" sz="2000" dirty="0" smtClean="0"/>
              <a:t>surface.</a:t>
            </a:r>
            <a:endParaRPr lang="en-US" sz="20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0" y="1371600"/>
            <a:ext cx="6600027" cy="51218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580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l"/>
            <a:r>
              <a:rPr lang="en-US" sz="2000" dirty="0" smtClean="0"/>
              <a:t>B) Screenshot </a:t>
            </a:r>
            <a:r>
              <a:rPr lang="en-US" sz="2000" dirty="0"/>
              <a:t>of motion (vector data</a:t>
            </a:r>
            <a:r>
              <a:rPr lang="en-US" sz="2000" dirty="0" smtClean="0"/>
              <a:t>).</a:t>
            </a:r>
            <a:endParaRPr lang="en-US" sz="20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" y="1089891"/>
            <a:ext cx="8001000" cy="56440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77040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l"/>
            <a:r>
              <a:rPr lang="en-US" sz="2000" dirty="0"/>
              <a:t>C</a:t>
            </a:r>
            <a:r>
              <a:rPr lang="en-US" sz="2000" dirty="0" smtClean="0"/>
              <a:t>) Questionnaire </a:t>
            </a:r>
            <a:r>
              <a:rPr lang="en-US" sz="2000" dirty="0"/>
              <a:t>on the “Learning management system” </a:t>
            </a:r>
            <a:r>
              <a:rPr lang="en-US" sz="2000" dirty="0" smtClean="0"/>
              <a:t>.</a:t>
            </a:r>
            <a:endParaRPr lang="en-US" sz="20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1437619"/>
            <a:ext cx="6249548" cy="5344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97854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</TotalTime>
  <Words>28</Words>
  <Application>Microsoft Office PowerPoint</Application>
  <PresentationFormat>On-screen Show (4:3)</PresentationFormat>
  <Paragraphs>3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A) Markers on the body surface.</vt:lpstr>
      <vt:lpstr>B) Screenshot of motion (vector data).</vt:lpstr>
      <vt:lpstr>C) Questionnaire on the “Learning management system” .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yo</dc:creator>
  <cp:lastModifiedBy>Ryo</cp:lastModifiedBy>
  <cp:revision>6</cp:revision>
  <dcterms:created xsi:type="dcterms:W3CDTF">2012-05-14T02:16:19Z</dcterms:created>
  <dcterms:modified xsi:type="dcterms:W3CDTF">2012-05-14T06:12:56Z</dcterms:modified>
</cp:coreProperties>
</file>